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053596727"/>
              </p:ext>
            </p:extLst>
          </p:nvPr>
        </p:nvGraphicFramePr>
        <p:xfrm>
          <a:off x="1447802" y="1904110"/>
          <a:ext cx="6095996" cy="2339181"/>
        </p:xfrm>
        <a:graphic>
          <a:graphicData uri="http://schemas.openxmlformats.org/drawingml/2006/table">
            <a:tbl>
              <a:tblPr/>
              <a:tblGrid>
                <a:gridCol w="1577946"/>
                <a:gridCol w="903610"/>
                <a:gridCol w="903610"/>
                <a:gridCol w="903610"/>
                <a:gridCol w="903610"/>
                <a:gridCol w="903610"/>
              </a:tblGrid>
              <a:tr h="34113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node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ample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4113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113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read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,142,7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,857,42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,642,99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,517,8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,290,24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2488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nted fragments (%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488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unique fragments (%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488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non-specifically (%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4113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counted (%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371600" y="1041737"/>
            <a:ext cx="6248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ea typeface="Times New Roman"/>
              </a:rPr>
              <a:t>Additional file 3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and percentag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mapped and unmapp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ads generated from four successive subapical internodes of bioenergy sorghum genotype R.07020 at 60 DAP (days after planting). The RNA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ads were mapped to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rghum Sbicolor-v3.1 reference sequenc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tozom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mprising 47,205 protein-cod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s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xmlns="" val="15859708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95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4:08Z</dcterms:modified>
</cp:coreProperties>
</file>